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25D070-0C0B-47B3-8BBB-9E49C67EEF80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756400-569D-4431-8947-6DCEF275C5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0299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995F3A-8CE1-436B-9749-52B7C8CA784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316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4DF12E-D9CC-4F70-9CA5-485146836C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46816B-C02D-4BE9-A4FD-3E066AEE9B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87645-06F8-4C1D-8A7F-5C66606B3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6605BC-2CC2-4D6B-BEF2-22C3BB19B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08A3FB-D4AE-4459-8162-061807395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30009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74954-B0B6-4BD9-8B52-7AC4751134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891DFA-9489-43E2-96CC-2A995A686A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C331E-F3BA-4004-BD3D-35EDB36F8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11215-05CA-40C5-9C20-EEE4FEECB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FDE081-29E3-49A4-BE22-A58EE5ED9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6252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EC60A1-7BA6-49DA-A915-8EBB3FEE57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609F30-0EF8-4976-859C-1751BE0D15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1BF767-DFEC-4AA5-AAFC-33458EBC3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75E924-AEE5-47BE-8EAB-F007A316F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59334C-198D-49F7-9BD4-70DF0F43E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9841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FB9BA-3CF8-4ED0-9D3E-7F61525B3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6871E3-D7D3-49E4-BC78-8ACB1BB8F8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362AE7-4B47-4C43-B73C-D50099367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92E2E3-9978-40CC-8634-F028C2E2D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1DC609-7300-463F-B54B-511833D6B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5011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AD6C4-E24C-45A0-9864-7D06D33D3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D97FFE-29BE-4F60-8BE6-B04D2E2A5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4140D-84AE-451E-8B9C-D081B1040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A1A945-096B-439F-AAE3-F01D61931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81337-BB2E-4C7C-AA55-C1830662C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4346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850B8-4884-4755-99CB-ADAC803FF4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8B6983-9617-4917-8CF0-18ED17AD7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63AD47-80F4-4735-9026-687AB1BEFB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EDAC59-B612-4F62-A4D3-A1A380345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5B08E-3D18-4F3B-8ACF-7064B9CFE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6B957D-6A86-4FCF-92D5-C96FBC03F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3837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C8CCBE-299A-4D78-BDE5-42E149511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D1F00-3CA8-419E-9195-2E82DA0D2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4CB991-69E7-42F3-9C33-6148972C95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B452E9-63BB-4F8C-8D88-AB5EDD44EE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CBAB1D-511C-453C-B21B-65BC8C06C5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D0F6EA-80A1-410A-B205-3E89ED544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5BABE2-7DDA-4F22-8142-4269C96EE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4DBB19-C719-41DC-9888-1FDC71C29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315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96456-758D-4D3C-8B50-0E702B3740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02919C-98E0-4194-9976-B6AE01F1B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73230C-7A9F-4F3E-BDF9-314BE378D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CA1BB8-BE34-4600-AC2E-7EAA81F53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5744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0C017B-B7AA-4B95-859D-1A4A71D98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FD2A4B-4C63-4F2F-9F40-98D010F5D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9EAEED-52EE-4539-9468-A85CB84C7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7868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B5A5B-53EB-469A-92AD-A6E5DE33A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0B16E-BCFC-4946-ACC6-78AD7409A4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C0C47B-BA89-4849-B753-2485BEE15E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D192FE-FA10-4D42-A662-135A3E988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EEEDCE-276D-4872-BA88-97F086058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24D277-55A6-44C9-A615-C32A5662D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2355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9BCA0-0AD7-4463-8910-644BCE16B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F9C49C-80D5-4C4B-BC55-561A68AC23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3D0F65-D24A-464F-AD94-E3F22073A2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A3AEC9-1C07-4CC5-B8B9-3726E9041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4A4E37-AD6D-4A4A-9832-B6309E47C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3D6924-D3E4-4568-9DE8-08DB4A060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3594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3147E4-1758-4DE4-8C60-E496C688A3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312804-0B90-48BA-BA15-7D53B7B27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46A2AC-55EE-42A0-991D-8C0B60162A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D9649-597A-4A85-8A75-DA40DE8F55BF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28590D-1740-4D3B-AF60-3F69A9D5F0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55B21B-36CB-4197-8E80-4CE648AD96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10AEE-4508-4F63-87A5-3CF5F53CF3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3680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1731C89B-BDBE-437A-85BF-182ECF3508FD}"/>
              </a:ext>
            </a:extLst>
          </p:cNvPr>
          <p:cNvSpPr/>
          <p:nvPr/>
        </p:nvSpPr>
        <p:spPr>
          <a:xfrm>
            <a:off x="2921219" y="808773"/>
            <a:ext cx="65219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1 Table</a:t>
            </a:r>
            <a:r>
              <a:rPr lang="en-US" dirty="0"/>
              <a:t>. </a:t>
            </a:r>
            <a:r>
              <a:rPr lang="en-US" b="1" dirty="0"/>
              <a:t>Oligonucleotides used for amplification and sequencing of </a:t>
            </a:r>
            <a:r>
              <a:rPr lang="en-US" b="1" i="1" dirty="0"/>
              <a:t>Pvama1</a:t>
            </a:r>
            <a:r>
              <a:rPr lang="en-US" b="1" dirty="0"/>
              <a:t>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msp1</a:t>
            </a:r>
            <a:r>
              <a:rPr lang="en-US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lang="en-US" b="1" dirty="0"/>
              <a:t> </a:t>
            </a:r>
            <a:endParaRPr lang="en-US" dirty="0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F861AD5-9FA4-4619-A9C9-E11F5209222C}"/>
              </a:ext>
            </a:extLst>
          </p:cNvPr>
          <p:cNvGraphicFramePr>
            <a:graphicFrameLocks noGrp="1"/>
          </p:cNvGraphicFramePr>
          <p:nvPr/>
        </p:nvGraphicFramePr>
        <p:xfrm>
          <a:off x="2921219" y="1718482"/>
          <a:ext cx="6317375" cy="2632140"/>
        </p:xfrm>
        <a:graphic>
          <a:graphicData uri="http://schemas.openxmlformats.org/drawingml/2006/table">
            <a:tbl>
              <a:tblPr firstRow="1" firstCol="1" bandRow="1"/>
              <a:tblGrid>
                <a:gridCol w="1734864">
                  <a:extLst>
                    <a:ext uri="{9D8B030D-6E8A-4147-A177-3AD203B41FA5}">
                      <a16:colId xmlns:a16="http://schemas.microsoft.com/office/drawing/2014/main" val="1870439192"/>
                    </a:ext>
                  </a:extLst>
                </a:gridCol>
                <a:gridCol w="2023997">
                  <a:extLst>
                    <a:ext uri="{9D8B030D-6E8A-4147-A177-3AD203B41FA5}">
                      <a16:colId xmlns:a16="http://schemas.microsoft.com/office/drawing/2014/main" val="2316378154"/>
                    </a:ext>
                  </a:extLst>
                </a:gridCol>
                <a:gridCol w="2558514">
                  <a:extLst>
                    <a:ext uri="{9D8B030D-6E8A-4147-A177-3AD203B41FA5}">
                      <a16:colId xmlns:a16="http://schemas.microsoft.com/office/drawing/2014/main" val="2435951002"/>
                    </a:ext>
                  </a:extLst>
                </a:gridCol>
              </a:tblGrid>
              <a:tr h="321434">
                <a:tc>
                  <a:txBody>
                    <a:bodyPr/>
                    <a:lstStyle/>
                    <a:p>
                      <a:pPr algn="ctr"/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imer Nam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to 3’ Primer Sequence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6982543"/>
                  </a:ext>
                </a:extLst>
              </a:tr>
              <a:tr h="294613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R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F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CAACAACGTTCTACTGGAAAAG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8119327"/>
                  </a:ext>
                </a:extLst>
              </a:tr>
              <a:tr h="29461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R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ACACGCCACCAGTTATTCC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9153349"/>
                  </a:ext>
                </a:extLst>
              </a:tr>
              <a:tr h="294613">
                <a:tc row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quencing 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F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CAACAACGTTCTACTGGAAAAG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8655366"/>
                  </a:ext>
                </a:extLst>
              </a:tr>
              <a:tr h="29461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R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ACACGCCACCAGTTATTCC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819949"/>
                  </a:ext>
                </a:extLst>
              </a:tr>
              <a:tr h="29461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Int_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TAATGATTGGGATAAAAAATGCC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1519709"/>
                  </a:ext>
                </a:extLst>
              </a:tr>
              <a:tr h="294613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AMA1_Int_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ACCCACTGGAAGAAAGGC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7865997"/>
                  </a:ext>
                </a:extLst>
              </a:tr>
              <a:tr h="2946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R &amp; Sequencing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vMSP1_F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ATCAAAATTGATTAAAGAAAAC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412596"/>
                  </a:ext>
                </a:extLst>
              </a:tr>
              <a:tr h="14397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b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vMSP1_R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CTGCACTTTTATTTGTG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3111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56230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4</Words>
  <Application>Microsoft Office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omic</dc:creator>
  <cp:lastModifiedBy>Prashant Mallick</cp:lastModifiedBy>
  <cp:revision>1</cp:revision>
  <dcterms:created xsi:type="dcterms:W3CDTF">2021-07-07T12:19:51Z</dcterms:created>
  <dcterms:modified xsi:type="dcterms:W3CDTF">2021-07-21T17:33:29Z</dcterms:modified>
</cp:coreProperties>
</file>